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11430000"/>
  <p:notesSz cx="6858000" cy="11430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146D1E-7610-4F45-A6FF-6D2EB31D950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458640"/>
            <a:ext cx="6172200" cy="1905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666520"/>
            <a:ext cx="6172200" cy="359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6606000"/>
            <a:ext cx="6172200" cy="359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AFDD19-555A-49C6-BE61-A2F37AC0CF6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458640"/>
            <a:ext cx="6172200" cy="1905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666520"/>
            <a:ext cx="3011760" cy="359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666520"/>
            <a:ext cx="3011760" cy="359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6606000"/>
            <a:ext cx="3011760" cy="359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6606000"/>
            <a:ext cx="3011760" cy="359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CB643C-63EB-4263-8095-72B95FBFB0E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458640"/>
            <a:ext cx="6172200" cy="1905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666520"/>
            <a:ext cx="1987200" cy="359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666520"/>
            <a:ext cx="1987200" cy="359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666520"/>
            <a:ext cx="1987200" cy="359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6606000"/>
            <a:ext cx="1987200" cy="359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6606000"/>
            <a:ext cx="1987200" cy="359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6606000"/>
            <a:ext cx="1987200" cy="359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0797EC-3942-4BFB-A138-0C953CE737F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458640"/>
            <a:ext cx="6172200" cy="1905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666520"/>
            <a:ext cx="6172200" cy="754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1FD253-6D0F-4055-A482-5E14EF6BBB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458640"/>
            <a:ext cx="6172200" cy="1905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666520"/>
            <a:ext cx="6172200" cy="754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FD13DA-D1CD-490D-8307-F3B966523D7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458640"/>
            <a:ext cx="6172200" cy="1905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666520"/>
            <a:ext cx="3011760" cy="754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666520"/>
            <a:ext cx="3011760" cy="754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782902-089B-43E4-9769-D49135D10A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458640"/>
            <a:ext cx="6172200" cy="1905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7E8ED3-0EA4-4155-B310-0A957F2B3C7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458640"/>
            <a:ext cx="6172200" cy="8832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09A68F-F96D-4945-9515-A0AA2668DAE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458640"/>
            <a:ext cx="6172200" cy="1905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666520"/>
            <a:ext cx="3011760" cy="359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666520"/>
            <a:ext cx="3011760" cy="754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6606000"/>
            <a:ext cx="3011760" cy="359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DF7982-E23B-4B4B-91B3-9116E9B761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458640"/>
            <a:ext cx="6172200" cy="1905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666520"/>
            <a:ext cx="3011760" cy="754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666520"/>
            <a:ext cx="3011760" cy="359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6606000"/>
            <a:ext cx="3011760" cy="359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B89F9F-FB82-4521-BB3C-866AE5FEB4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458640"/>
            <a:ext cx="6172200" cy="1905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666520"/>
            <a:ext cx="3011760" cy="359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666520"/>
            <a:ext cx="3011760" cy="359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6606000"/>
            <a:ext cx="6172200" cy="359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088AD9-004A-4CB3-A165-1793D02039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458640"/>
            <a:ext cx="6172200" cy="1905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666520"/>
            <a:ext cx="6172200" cy="754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10407240"/>
            <a:ext cx="1600200" cy="795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10407240"/>
            <a:ext cx="2171520" cy="795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10407240"/>
            <a:ext cx="1600200" cy="795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765FEAE-DFBB-46F6-A0D2-3B702914205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26800" y="608040"/>
            <a:ext cx="2032560" cy="1068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G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00757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   AC13668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2493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91565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   AC13756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251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386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11767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   AC01620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9076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   AC01644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                      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3506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16116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  AC13670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16165         AC14125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GA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00756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 AC10075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73446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 AC1093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26407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 AC10075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732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214309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 AC1037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87490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 AC0691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21439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 AC06795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8747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87463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 AC02609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3936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3914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00720       AC01909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90893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AC00473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90602      AC0260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2431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AC00969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U4138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24303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AC1264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00774      AC08400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0425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24997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AC1243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046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807720" y="579600"/>
            <a:ext cx="904680" cy="10497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215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1176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1644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11611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7344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723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6913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2143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6795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2609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1909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0969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8400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0046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588760" y="600120"/>
            <a:ext cx="1183680" cy="10497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H4567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H778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H4708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H670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HGC11236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15S9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15S54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15S54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15S1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HGC-11259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15354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HGC15277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H5416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HGC14691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HGC8468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H5432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H138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HGC15564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HGC14811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H10201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HGC1437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H3964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HGC10590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HGC4464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H5434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15S67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15S1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HGC11239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HGC1377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15S6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15S67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15S67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H7020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15S67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H2518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H4509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HGC8110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15S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6003360" y="565200"/>
            <a:ext cx="494640" cy="10497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p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p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p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p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p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p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p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p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p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p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p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52280" y="237960"/>
            <a:ext cx="18432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33200" y="334800"/>
            <a:ext cx="6715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AC(1x)           BAC(3-4 x)            STS                    BAC-FISH           Gene/EST    CpG islan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76320" y="609480"/>
            <a:ext cx="6629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76320" y="304920"/>
            <a:ext cx="6629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0" y="11430000"/>
            <a:ext cx="6858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5013000" y="573120"/>
            <a:ext cx="1107360" cy="1068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ERC2LC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GOLGA8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K09310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WHDC1L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IPA1/NIPA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’ CYFIP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’ CYFIP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GCP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K09346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K0934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K12576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K09346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G72169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L04023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KRN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AGEL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D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K82092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WRN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C03295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K05814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WRN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A42422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15ORF2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8000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NUR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NRP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noRNA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PW/PWCR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UBE3A-3’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UBE3A-5’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5640" y="36360"/>
            <a:ext cx="6458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able S1: Overlapping BAC clone, STS makers, ESTs  cross the PWS candidate reg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228600" y="11283840"/>
            <a:ext cx="6629400" cy="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6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3-06-26T15:07:12Z</dcterms:created>
  <dc:creator>Yonghui Jiang</dc:creator>
  <dc:description/>
  <dc:language>en-US</dc:language>
  <cp:lastModifiedBy>yjiang</cp:lastModifiedBy>
  <dcterms:modified xsi:type="dcterms:W3CDTF">2007-11-21T22:57:12Z</dcterms:modified>
  <cp:revision>63</cp:revision>
  <dc:subject/>
  <dc:title>Slide 1</dc:title>
</cp:coreProperties>
</file>